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493E91D-2743-467F-9181-140E2E6C85F7}" type="datetime">
              <a:rPr b="0" lang="es-ES" sz="1200" spc="-1" strike="noStrike">
                <a:solidFill>
                  <a:srgbClr val="000000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A5152E2-ED2A-44E1-8D1E-456F7C809417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dditional file 1- Schematic representation of the assembled data from Drosophila telomeres (source: http://flybase.org)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XL, left telomere chromosome X (aprox. 20 Kb). 4R, right telomere chromosome 4 (aprox. 70 Kb). Names of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HeT-A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opies indicated. Domains of complete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HeT-A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element, 5’UTR,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gag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gene and 3’UTR (dotted, smooth and lined boxes, respectively) are indicated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3 Marcador de número de diapositiva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464C263-B6FC-41A5-9167-6AED7F3C8190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1488ED-8D50-4286-A22D-3A86E640D8D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A14089-63E9-4F01-99BE-8D4316A15DF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33991A-62E3-4AD2-94D8-BB8635F5C4E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8BF724-F9B9-4EB2-A27F-F88A5A5C8DC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AC45E9-7386-49CD-8321-3F9C6C6645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6FBC8C-035C-4101-95AD-A5867325A6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BEE561-E101-4290-BED7-B4F026BBEE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EF4D8C-7793-4566-A20B-D2C712261C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6268F0-BBBA-4ED4-BA5F-494916D7A8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05B285-178A-481A-A390-051A9E17CE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6BCA8B-E385-4BBC-9B82-4BEBB3A87A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17DD5F-727A-460F-A973-1AD86DF94E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C34D19A-A78B-4C8F-BC0A-FB025F06D29D}" type="datetime">
              <a:rPr b="0" lang="es-ES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ECE6CB-BDB1-48E0-95BE-245438E5705E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image" Target="../media/image2.png"/><Relationship Id="rId9" Type="http://schemas.openxmlformats.org/officeDocument/2006/relationships/image" Target="../media/image1.png"/><Relationship Id="rId10" Type="http://schemas.openxmlformats.org/officeDocument/2006/relationships/image" Target="../media/image2.png"/><Relationship Id="rId11" Type="http://schemas.openxmlformats.org/officeDocument/2006/relationships/image" Target="../media/image1.png"/><Relationship Id="rId12" Type="http://schemas.openxmlformats.org/officeDocument/2006/relationships/image" Target="../media/image2.png"/><Relationship Id="rId13" Type="http://schemas.openxmlformats.org/officeDocument/2006/relationships/image" Target="../media/image1.png"/><Relationship Id="rId14" Type="http://schemas.openxmlformats.org/officeDocument/2006/relationships/image" Target="../media/image2.png"/><Relationship Id="rId15" Type="http://schemas.openxmlformats.org/officeDocument/2006/relationships/image" Target="../media/image1.png"/><Relationship Id="rId16" Type="http://schemas.openxmlformats.org/officeDocument/2006/relationships/image" Target="../media/image2.png"/><Relationship Id="rId17" Type="http://schemas.openxmlformats.org/officeDocument/2006/relationships/image" Target="../media/image1.png"/><Relationship Id="rId18" Type="http://schemas.openxmlformats.org/officeDocument/2006/relationships/image" Target="../media/image2.png"/><Relationship Id="rId19" Type="http://schemas.openxmlformats.org/officeDocument/2006/relationships/image" Target="../media/image2.png"/><Relationship Id="rId20" Type="http://schemas.openxmlformats.org/officeDocument/2006/relationships/image" Target="../media/image2.png"/><Relationship Id="rId21" Type="http://schemas.openxmlformats.org/officeDocument/2006/relationships/image" Target="../media/image2.png"/><Relationship Id="rId22" Type="http://schemas.openxmlformats.org/officeDocument/2006/relationships/image" Target="../media/image2.png"/><Relationship Id="rId23" Type="http://schemas.openxmlformats.org/officeDocument/2006/relationships/image" Target="../media/image2.png"/><Relationship Id="rId24" Type="http://schemas.openxmlformats.org/officeDocument/2006/relationships/slideLayout" Target="../slideLayouts/slideLayout1.xml"/><Relationship Id="rId2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140 CuadroTexto"/>
          <p:cNvSpPr/>
          <p:nvPr/>
        </p:nvSpPr>
        <p:spPr>
          <a:xfrm>
            <a:off x="8825040" y="4435560"/>
            <a:ext cx="571320" cy="69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90960" rIns="390960" tIns="195480" bIns="1954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2000" spc="-1" strike="noStrike">
                <a:solidFill>
                  <a:srgbClr val="000000"/>
                </a:solidFill>
                <a:latin typeface="Calibri"/>
              </a:rPr>
              <a:t>…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141 CuadroTexto"/>
          <p:cNvSpPr/>
          <p:nvPr/>
        </p:nvSpPr>
        <p:spPr>
          <a:xfrm>
            <a:off x="-103320" y="847800"/>
            <a:ext cx="714600" cy="69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90960" rIns="390960" tIns="195480" bIns="1954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2000" spc="-1" strike="noStrike">
                <a:solidFill>
                  <a:srgbClr val="000000"/>
                </a:solidFill>
                <a:latin typeface="Calibri"/>
              </a:rPr>
              <a:t>…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4 CuadroTexto"/>
          <p:cNvSpPr/>
          <p:nvPr/>
        </p:nvSpPr>
        <p:spPr>
          <a:xfrm rot="19171800">
            <a:off x="2203920" y="474480"/>
            <a:ext cx="71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</a:rPr>
              <a:t>XL48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7 CuadroTexto"/>
          <p:cNvSpPr/>
          <p:nvPr/>
        </p:nvSpPr>
        <p:spPr>
          <a:xfrm rot="19156800">
            <a:off x="1411200" y="473040"/>
            <a:ext cx="719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</a:rPr>
              <a:t>XL479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9 CuadroTexto"/>
          <p:cNvSpPr/>
          <p:nvPr/>
        </p:nvSpPr>
        <p:spPr>
          <a:xfrm rot="19129200">
            <a:off x="1108080" y="471240"/>
            <a:ext cx="71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</a:rPr>
              <a:t>XL625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10 CuadroTexto"/>
          <p:cNvSpPr/>
          <p:nvPr/>
        </p:nvSpPr>
        <p:spPr>
          <a:xfrm rot="19104000">
            <a:off x="709200" y="469800"/>
            <a:ext cx="71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</a:rPr>
              <a:t>XL625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11 CuadroTexto"/>
          <p:cNvSpPr/>
          <p:nvPr/>
        </p:nvSpPr>
        <p:spPr>
          <a:xfrm rot="19114200">
            <a:off x="1773360" y="471240"/>
            <a:ext cx="71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</a:rPr>
              <a:t>XL550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46 CuadroTexto"/>
          <p:cNvSpPr/>
          <p:nvPr/>
        </p:nvSpPr>
        <p:spPr>
          <a:xfrm rot="19164000">
            <a:off x="1762200" y="4178160"/>
            <a:ext cx="64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</a:rPr>
              <a:t>4R627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47 CuadroTexto"/>
          <p:cNvSpPr/>
          <p:nvPr/>
        </p:nvSpPr>
        <p:spPr>
          <a:xfrm rot="19164000">
            <a:off x="2492280" y="4177800"/>
            <a:ext cx="641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</a:rPr>
              <a:t>4R627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48 CuadroTexto"/>
          <p:cNvSpPr/>
          <p:nvPr/>
        </p:nvSpPr>
        <p:spPr>
          <a:xfrm rot="19164000">
            <a:off x="4653000" y="4178160"/>
            <a:ext cx="64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</a:rPr>
              <a:t>4R626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49 CuadroTexto"/>
          <p:cNvSpPr/>
          <p:nvPr/>
        </p:nvSpPr>
        <p:spPr>
          <a:xfrm rot="19164000">
            <a:off x="3932280" y="4178160"/>
            <a:ext cx="64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</a:rPr>
              <a:t>4R626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50 CuadroTexto"/>
          <p:cNvSpPr/>
          <p:nvPr/>
        </p:nvSpPr>
        <p:spPr>
          <a:xfrm rot="19164000">
            <a:off x="5300640" y="4177800"/>
            <a:ext cx="641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</a:rPr>
              <a:t>4R626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51 CuadroTexto"/>
          <p:cNvSpPr/>
          <p:nvPr/>
        </p:nvSpPr>
        <p:spPr>
          <a:xfrm rot="19164000">
            <a:off x="2924280" y="4178160"/>
            <a:ext cx="64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</a:rPr>
              <a:t>4R627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52 CuadroTexto"/>
          <p:cNvSpPr/>
          <p:nvPr/>
        </p:nvSpPr>
        <p:spPr>
          <a:xfrm rot="19164000">
            <a:off x="1401840" y="4178160"/>
            <a:ext cx="64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</a:rPr>
              <a:t>4R627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53 CuadroTexto"/>
          <p:cNvSpPr/>
          <p:nvPr/>
        </p:nvSpPr>
        <p:spPr>
          <a:xfrm rot="19164000">
            <a:off x="3284640" y="4178160"/>
            <a:ext cx="64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</a:rPr>
              <a:t>4R626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54 CuadroTexto"/>
          <p:cNvSpPr/>
          <p:nvPr/>
        </p:nvSpPr>
        <p:spPr>
          <a:xfrm rot="19164000">
            <a:off x="1123920" y="4177800"/>
            <a:ext cx="641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</a:rPr>
              <a:t>4R627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104 CuadroTexto"/>
          <p:cNvSpPr/>
          <p:nvPr/>
        </p:nvSpPr>
        <p:spPr>
          <a:xfrm>
            <a:off x="511200" y="2057400"/>
            <a:ext cx="1905120" cy="75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90960" rIns="390960" tIns="195480" bIns="1954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Calibri"/>
              </a:rPr>
              <a:t>HeT-A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 copies and fragmen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105 Abrir llave"/>
          <p:cNvSpPr/>
          <p:nvPr/>
        </p:nvSpPr>
        <p:spPr>
          <a:xfrm flipH="1" rot="5400000">
            <a:off x="1298880" y="790560"/>
            <a:ext cx="563400" cy="2095560"/>
          </a:xfrm>
          <a:custGeom>
            <a:avLst/>
            <a:gdLst>
              <a:gd name="textAreaLeft" fmla="*/ 359640 w 563400"/>
              <a:gd name="textAreaRight" fmla="*/ 563400 w 563400"/>
              <a:gd name="textAreaTop" fmla="*/ 14400 h 2095560"/>
              <a:gd name="textAreaBottom" fmla="*/ 2081160 h 20955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242"/>
                  <a:pt x="10800" y="484"/>
                </a:cubicBezTo>
                <a:lnTo>
                  <a:pt x="10800" y="10316"/>
                </a:lnTo>
                <a:cubicBezTo>
                  <a:pt x="10800" y="10558"/>
                  <a:pt x="5400" y="10800"/>
                  <a:pt x="0" y="10800"/>
                </a:cubicBezTo>
                <a:cubicBezTo>
                  <a:pt x="5400" y="10800"/>
                  <a:pt x="10800" y="11042"/>
                  <a:pt x="10800" y="11284"/>
                </a:cubicBezTo>
                <a:lnTo>
                  <a:pt x="10800" y="21116"/>
                </a:lnTo>
                <a:cubicBezTo>
                  <a:pt x="10800" y="21358"/>
                  <a:pt x="16200" y="21600"/>
                  <a:pt x="2160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390960" rIns="390960" tIns="195480" bIns="1954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106 CuadroTexto"/>
          <p:cNvSpPr/>
          <p:nvPr/>
        </p:nvSpPr>
        <p:spPr>
          <a:xfrm>
            <a:off x="6000840" y="5442120"/>
            <a:ext cx="2638440" cy="75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90960" rIns="390960" tIns="195480" bIns="1954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Calibri"/>
              </a:rPr>
              <a:t>TART-A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 copies and fragmen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107 Abrir llave"/>
          <p:cNvSpPr/>
          <p:nvPr/>
        </p:nvSpPr>
        <p:spPr>
          <a:xfrm flipH="1" rot="5400000">
            <a:off x="7205760" y="3727440"/>
            <a:ext cx="257040" cy="3260880"/>
          </a:xfrm>
          <a:custGeom>
            <a:avLst/>
            <a:gdLst>
              <a:gd name="textAreaLeft" fmla="*/ 164520 w 257040"/>
              <a:gd name="textAreaRight" fmla="*/ 257760 w 257040"/>
              <a:gd name="textAreaTop" fmla="*/ 6480 h 3260880"/>
              <a:gd name="textAreaBottom" fmla="*/ 3254400 h 32608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71"/>
                  <a:pt x="10800" y="142"/>
                </a:cubicBezTo>
                <a:lnTo>
                  <a:pt x="10800" y="10658"/>
                </a:lnTo>
                <a:cubicBezTo>
                  <a:pt x="10800" y="10729"/>
                  <a:pt x="5400" y="10800"/>
                  <a:pt x="0" y="10800"/>
                </a:cubicBezTo>
                <a:cubicBezTo>
                  <a:pt x="5400" y="10800"/>
                  <a:pt x="10800" y="10871"/>
                  <a:pt x="10800" y="10942"/>
                </a:cubicBezTo>
                <a:lnTo>
                  <a:pt x="10800" y="21458"/>
                </a:lnTo>
                <a:cubicBezTo>
                  <a:pt x="10800" y="21529"/>
                  <a:pt x="16200" y="21600"/>
                  <a:pt x="2160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390960" rIns="390960" tIns="195480" bIns="1954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108 Abrir llave"/>
          <p:cNvSpPr/>
          <p:nvPr/>
        </p:nvSpPr>
        <p:spPr>
          <a:xfrm flipH="1" rot="5400000">
            <a:off x="3885480" y="3668040"/>
            <a:ext cx="257040" cy="3379680"/>
          </a:xfrm>
          <a:custGeom>
            <a:avLst/>
            <a:gdLst>
              <a:gd name="textAreaLeft" fmla="*/ 164520 w 257040"/>
              <a:gd name="textAreaRight" fmla="*/ 257760 w 257040"/>
              <a:gd name="textAreaTop" fmla="*/ 6480 h 3379680"/>
              <a:gd name="textAreaBottom" fmla="*/ 3373200 h 33796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69"/>
                  <a:pt x="10800" y="137"/>
                </a:cubicBezTo>
                <a:lnTo>
                  <a:pt x="10800" y="10663"/>
                </a:lnTo>
                <a:cubicBezTo>
                  <a:pt x="10800" y="10732"/>
                  <a:pt x="5400" y="10800"/>
                  <a:pt x="0" y="10800"/>
                </a:cubicBezTo>
                <a:cubicBezTo>
                  <a:pt x="5400" y="10800"/>
                  <a:pt x="10800" y="10869"/>
                  <a:pt x="10800" y="10937"/>
                </a:cubicBezTo>
                <a:lnTo>
                  <a:pt x="10800" y="21463"/>
                </a:lnTo>
                <a:cubicBezTo>
                  <a:pt x="10800" y="21532"/>
                  <a:pt x="16200" y="21600"/>
                  <a:pt x="2160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390960" rIns="390960" tIns="195480" bIns="1954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109 CuadroTexto"/>
          <p:cNvSpPr/>
          <p:nvPr/>
        </p:nvSpPr>
        <p:spPr>
          <a:xfrm>
            <a:off x="3036960" y="5442120"/>
            <a:ext cx="2044800" cy="93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90960" rIns="390960" tIns="195480" bIns="1954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Calibri"/>
              </a:rPr>
              <a:t>HeT-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Copies and fragmen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110 CuadroTexto"/>
          <p:cNvSpPr/>
          <p:nvPr/>
        </p:nvSpPr>
        <p:spPr>
          <a:xfrm>
            <a:off x="1562040" y="5445000"/>
            <a:ext cx="1714680" cy="75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90960" rIns="390960" tIns="195480" bIns="1954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Calibri"/>
              </a:rPr>
              <a:t>TART-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fragmen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111 CuadroTexto"/>
          <p:cNvSpPr/>
          <p:nvPr/>
        </p:nvSpPr>
        <p:spPr>
          <a:xfrm>
            <a:off x="871560" y="5442120"/>
            <a:ext cx="1539720" cy="75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90960" rIns="390960" tIns="195480" bIns="1954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Calibri"/>
              </a:rPr>
              <a:t>HeT-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fragmen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2" name="112 Conector recto de flecha"/>
          <p:cNvCxnSpPr/>
          <p:nvPr/>
        </p:nvCxnSpPr>
        <p:spPr>
          <a:xfrm flipV="1">
            <a:off x="2231640" y="5228640"/>
            <a:ext cx="1080" cy="3006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73" name="113 Abrir llave"/>
          <p:cNvSpPr/>
          <p:nvPr/>
        </p:nvSpPr>
        <p:spPr>
          <a:xfrm flipH="1" rot="5400000">
            <a:off x="1518480" y="4817520"/>
            <a:ext cx="233280" cy="1056960"/>
          </a:xfrm>
          <a:custGeom>
            <a:avLst/>
            <a:gdLst>
              <a:gd name="textAreaLeft" fmla="*/ 149400 w 233280"/>
              <a:gd name="textAreaRight" fmla="*/ 234000 w 233280"/>
              <a:gd name="textAreaTop" fmla="*/ 5760 h 1056960"/>
              <a:gd name="textAreaBottom" fmla="*/ 1051200 h 10569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99"/>
                  <a:pt x="10800" y="397"/>
                </a:cubicBezTo>
                <a:lnTo>
                  <a:pt x="10800" y="10403"/>
                </a:lnTo>
                <a:cubicBezTo>
                  <a:pt x="10800" y="10602"/>
                  <a:pt x="5400" y="10800"/>
                  <a:pt x="0" y="10800"/>
                </a:cubicBezTo>
                <a:cubicBezTo>
                  <a:pt x="5400" y="10800"/>
                  <a:pt x="10800" y="10999"/>
                  <a:pt x="10800" y="11197"/>
                </a:cubicBezTo>
                <a:lnTo>
                  <a:pt x="10800" y="21203"/>
                </a:lnTo>
                <a:cubicBezTo>
                  <a:pt x="10800" y="21402"/>
                  <a:pt x="16200" y="21600"/>
                  <a:pt x="2160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  <a:effectLst>
            <a:outerShdw dist="20160" dir="5400000" blurRad="0" rotWithShape="0">
              <a:srgbClr val="80808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390960" rIns="390960" tIns="195480" bIns="1954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4" name="116 Conector recto de flecha"/>
          <p:cNvCxnSpPr/>
          <p:nvPr/>
        </p:nvCxnSpPr>
        <p:spPr>
          <a:xfrm>
            <a:off x="3287520" y="1700280"/>
            <a:ext cx="1500840" cy="2160"/>
          </a:xfrm>
          <a:prstGeom prst="straightConnector1">
            <a:avLst/>
          </a:prstGeom>
          <a:ln w="316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75" name="117 CuadroTexto"/>
          <p:cNvSpPr/>
          <p:nvPr/>
        </p:nvSpPr>
        <p:spPr>
          <a:xfrm>
            <a:off x="3009960" y="1660680"/>
            <a:ext cx="1928880" cy="60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90960" rIns="390960" tIns="195480" bIns="1954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First gen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118 Rectángulo"/>
          <p:cNvSpPr/>
          <p:nvPr/>
        </p:nvSpPr>
        <p:spPr>
          <a:xfrm>
            <a:off x="2614680" y="977760"/>
            <a:ext cx="2143080" cy="443160"/>
          </a:xfrm>
          <a:prstGeom prst="rect">
            <a:avLst/>
          </a:prstGeom>
          <a:solidFill>
            <a:srgbClr val="7f7f7f">
              <a:alpha val="3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90960" rIns="390960" tIns="195480" bIns="1954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Chromosome ar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119 CuadroTexto"/>
          <p:cNvSpPr/>
          <p:nvPr/>
        </p:nvSpPr>
        <p:spPr>
          <a:xfrm>
            <a:off x="4572000" y="847800"/>
            <a:ext cx="714240" cy="69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90960" rIns="390960" tIns="195480" bIns="1954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2000" spc="-1" strike="noStrike">
                <a:solidFill>
                  <a:srgbClr val="000000"/>
                </a:solidFill>
                <a:latin typeface="Calibri"/>
              </a:rPr>
              <a:t>…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120 CuadroTexto"/>
          <p:cNvSpPr/>
          <p:nvPr/>
        </p:nvSpPr>
        <p:spPr>
          <a:xfrm>
            <a:off x="-343080" y="3519360"/>
            <a:ext cx="1235160" cy="75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90960" rIns="390960" tIns="195480" bIns="1954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4R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121 CuadroTexto"/>
          <p:cNvSpPr/>
          <p:nvPr/>
        </p:nvSpPr>
        <p:spPr>
          <a:xfrm>
            <a:off x="-368280" y="-119160"/>
            <a:ext cx="1282680" cy="75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90960" rIns="390960" tIns="195480" bIns="1954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X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122 CuadroTexto"/>
          <p:cNvSpPr/>
          <p:nvPr/>
        </p:nvSpPr>
        <p:spPr>
          <a:xfrm>
            <a:off x="-324000" y="5300640"/>
            <a:ext cx="1714680" cy="60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90960" rIns="390960" tIns="195480" bIns="1954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First gen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123 Rectángulo"/>
          <p:cNvSpPr/>
          <p:nvPr/>
        </p:nvSpPr>
        <p:spPr>
          <a:xfrm>
            <a:off x="252360" y="4641840"/>
            <a:ext cx="827280" cy="442800"/>
          </a:xfrm>
          <a:prstGeom prst="rect">
            <a:avLst/>
          </a:prstGeom>
          <a:solidFill>
            <a:srgbClr val="7f7f7f">
              <a:alpha val="3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90960" rIns="390960" tIns="195480" bIns="1954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124 CuadroTexto"/>
          <p:cNvSpPr/>
          <p:nvPr/>
        </p:nvSpPr>
        <p:spPr>
          <a:xfrm>
            <a:off x="-165240" y="4446720"/>
            <a:ext cx="571680" cy="69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90960" rIns="390960" tIns="195480" bIns="1954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2000" spc="-1" strike="noStrike">
                <a:solidFill>
                  <a:srgbClr val="000000"/>
                </a:solidFill>
                <a:latin typeface="Calibri"/>
              </a:rPr>
              <a:t>…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83" name="125 Conector recto de flecha"/>
          <p:cNvCxnSpPr/>
          <p:nvPr/>
        </p:nvCxnSpPr>
        <p:spPr>
          <a:xfrm flipH="1">
            <a:off x="120240" y="5343120"/>
            <a:ext cx="751680" cy="1080"/>
          </a:xfrm>
          <a:prstGeom prst="straightConnector1">
            <a:avLst/>
          </a:prstGeom>
          <a:ln w="316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84" name="137 Conector recto"/>
          <p:cNvSpPr/>
          <p:nvPr/>
        </p:nvSpPr>
        <p:spPr>
          <a:xfrm flipV="1">
            <a:off x="8891640" y="4498560"/>
            <a:ext cx="0" cy="57636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85" name="142 Conector recto de flecha"/>
          <p:cNvCxnSpPr/>
          <p:nvPr/>
        </p:nvCxnSpPr>
        <p:spPr>
          <a:xfrm>
            <a:off x="1071720" y="6484680"/>
            <a:ext cx="7812720" cy="1080"/>
          </a:xfrm>
          <a:prstGeom prst="straightConnector1">
            <a:avLst/>
          </a:prstGeom>
          <a:ln w="381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</p:cxnSp>
      <p:sp>
        <p:nvSpPr>
          <p:cNvPr id="86" name="143 CuadroTexto"/>
          <p:cNvSpPr/>
          <p:nvPr/>
        </p:nvSpPr>
        <p:spPr>
          <a:xfrm>
            <a:off x="4286160" y="6375240"/>
            <a:ext cx="1714680" cy="60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90960" rIns="390960" tIns="195480" bIns="19548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70 K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87" name="144 Conector recto de flecha"/>
          <p:cNvCxnSpPr/>
          <p:nvPr/>
        </p:nvCxnSpPr>
        <p:spPr>
          <a:xfrm>
            <a:off x="542880" y="3076200"/>
            <a:ext cx="2115360" cy="1080"/>
          </a:xfrm>
          <a:prstGeom prst="straightConnector1">
            <a:avLst/>
          </a:prstGeom>
          <a:ln w="381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</p:cxnSp>
      <p:sp>
        <p:nvSpPr>
          <p:cNvPr id="88" name="145 CuadroTexto"/>
          <p:cNvSpPr/>
          <p:nvPr/>
        </p:nvSpPr>
        <p:spPr>
          <a:xfrm>
            <a:off x="841320" y="2965320"/>
            <a:ext cx="1714680" cy="60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90960" rIns="390960" tIns="195480" bIns="19548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20 K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22 Rectángulo"/>
          <p:cNvSpPr/>
          <p:nvPr/>
        </p:nvSpPr>
        <p:spPr>
          <a:xfrm>
            <a:off x="5640480" y="2263680"/>
            <a:ext cx="360360" cy="314280"/>
          </a:xfrm>
          <a:prstGeom prst="rect">
            <a:avLst/>
          </a:prstGeom>
          <a:blipFill rotWithShape="0">
            <a:blip r:embed="rId1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146 Rectángulo"/>
          <p:cNvSpPr/>
          <p:nvPr/>
        </p:nvSpPr>
        <p:spPr>
          <a:xfrm>
            <a:off x="6000840" y="2268360"/>
            <a:ext cx="1008000" cy="3128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147 Rectángulo"/>
          <p:cNvSpPr/>
          <p:nvPr/>
        </p:nvSpPr>
        <p:spPr>
          <a:xfrm>
            <a:off x="7008840" y="2263680"/>
            <a:ext cx="936720" cy="31428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32 Cerrar llave"/>
          <p:cNvSpPr/>
          <p:nvPr/>
        </p:nvSpPr>
        <p:spPr>
          <a:xfrm rot="16200000">
            <a:off x="5732640" y="1936440"/>
            <a:ext cx="176040" cy="360360"/>
          </a:xfrm>
          <a:custGeom>
            <a:avLst/>
            <a:gdLst>
              <a:gd name="textAreaLeft" fmla="*/ 0 w 176040"/>
              <a:gd name="textAreaRight" fmla="*/ 63360 w 176040"/>
              <a:gd name="textAreaTop" fmla="*/ 4320 h 360360"/>
              <a:gd name="textAreaBottom" fmla="*/ 356040 h 3603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440"/>
                  <a:pt x="10800" y="880"/>
                </a:cubicBezTo>
                <a:lnTo>
                  <a:pt x="10800" y="9920"/>
                </a:lnTo>
                <a:cubicBezTo>
                  <a:pt x="10800" y="10360"/>
                  <a:pt x="16200" y="10800"/>
                  <a:pt x="21600" y="10800"/>
                </a:cubicBezTo>
                <a:cubicBezTo>
                  <a:pt x="16200" y="10800"/>
                  <a:pt x="10800" y="11240"/>
                  <a:pt x="10800" y="11680"/>
                </a:cubicBezTo>
                <a:lnTo>
                  <a:pt x="10800" y="20720"/>
                </a:lnTo>
                <a:cubicBezTo>
                  <a:pt x="10800" y="2116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148 Cerrar llave"/>
          <p:cNvSpPr/>
          <p:nvPr/>
        </p:nvSpPr>
        <p:spPr>
          <a:xfrm rot="16200000">
            <a:off x="6416640" y="1612440"/>
            <a:ext cx="176040" cy="1008000"/>
          </a:xfrm>
          <a:custGeom>
            <a:avLst/>
            <a:gdLst>
              <a:gd name="textAreaLeft" fmla="*/ 0 w 176040"/>
              <a:gd name="textAreaRight" fmla="*/ 63360 w 176040"/>
              <a:gd name="textAreaTop" fmla="*/ 4320 h 1008000"/>
              <a:gd name="textAreaBottom" fmla="*/ 1003680 h 1008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58"/>
                  <a:pt x="10800" y="315"/>
                </a:cubicBezTo>
                <a:lnTo>
                  <a:pt x="10800" y="10485"/>
                </a:lnTo>
                <a:cubicBezTo>
                  <a:pt x="10800" y="10643"/>
                  <a:pt x="16200" y="10800"/>
                  <a:pt x="21600" y="10800"/>
                </a:cubicBezTo>
                <a:cubicBezTo>
                  <a:pt x="16200" y="10800"/>
                  <a:pt x="10800" y="10958"/>
                  <a:pt x="10800" y="11115"/>
                </a:cubicBezTo>
                <a:lnTo>
                  <a:pt x="10800" y="21285"/>
                </a:lnTo>
                <a:cubicBezTo>
                  <a:pt x="10800" y="21443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149 Cerrar llave"/>
          <p:cNvSpPr/>
          <p:nvPr/>
        </p:nvSpPr>
        <p:spPr>
          <a:xfrm rot="16200000">
            <a:off x="7400880" y="1647360"/>
            <a:ext cx="157320" cy="932040"/>
          </a:xfrm>
          <a:custGeom>
            <a:avLst/>
            <a:gdLst>
              <a:gd name="textAreaLeft" fmla="*/ 0 w 157320"/>
              <a:gd name="textAreaRight" fmla="*/ 56880 w 157320"/>
              <a:gd name="textAreaTop" fmla="*/ 3960 h 932040"/>
              <a:gd name="textAreaBottom" fmla="*/ 928080 h 932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52"/>
                  <a:pt x="10800" y="304"/>
                </a:cubicBezTo>
                <a:lnTo>
                  <a:pt x="10800" y="10496"/>
                </a:lnTo>
                <a:cubicBezTo>
                  <a:pt x="10800" y="10648"/>
                  <a:pt x="16200" y="10800"/>
                  <a:pt x="21600" y="10800"/>
                </a:cubicBezTo>
                <a:cubicBezTo>
                  <a:pt x="16200" y="10800"/>
                  <a:pt x="10800" y="10952"/>
                  <a:pt x="10800" y="11104"/>
                </a:cubicBezTo>
                <a:lnTo>
                  <a:pt x="10800" y="21296"/>
                </a:lnTo>
                <a:cubicBezTo>
                  <a:pt x="10800" y="21448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33 CuadroTexto"/>
          <p:cNvSpPr/>
          <p:nvPr/>
        </p:nvSpPr>
        <p:spPr>
          <a:xfrm>
            <a:off x="5435640" y="1619280"/>
            <a:ext cx="768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Calibri"/>
              </a:rPr>
              <a:t>5’UT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150 CuadroTexto"/>
          <p:cNvSpPr/>
          <p:nvPr/>
        </p:nvSpPr>
        <p:spPr>
          <a:xfrm>
            <a:off x="7095960" y="1619280"/>
            <a:ext cx="766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Calibri"/>
              </a:rPr>
              <a:t>3’UT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151 CuadroTexto"/>
          <p:cNvSpPr/>
          <p:nvPr/>
        </p:nvSpPr>
        <p:spPr>
          <a:xfrm>
            <a:off x="6175440" y="1619280"/>
            <a:ext cx="658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800" spc="-1" strike="noStrike">
                <a:solidFill>
                  <a:srgbClr val="000000"/>
                </a:solidFill>
                <a:latin typeface="Calibri"/>
              </a:rPr>
              <a:t>gag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158 Rectángulo"/>
          <p:cNvSpPr/>
          <p:nvPr/>
        </p:nvSpPr>
        <p:spPr>
          <a:xfrm>
            <a:off x="1963800" y="973080"/>
            <a:ext cx="104760" cy="44784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159 Rectángulo"/>
          <p:cNvSpPr/>
          <p:nvPr/>
        </p:nvSpPr>
        <p:spPr>
          <a:xfrm>
            <a:off x="2066760" y="988920"/>
            <a:ext cx="312840" cy="443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160 Rectángulo"/>
          <p:cNvSpPr/>
          <p:nvPr/>
        </p:nvSpPr>
        <p:spPr>
          <a:xfrm>
            <a:off x="2376360" y="988920"/>
            <a:ext cx="252720" cy="443160"/>
          </a:xfrm>
          <a:prstGeom prst="rect">
            <a:avLst/>
          </a:prstGeom>
          <a:blipFill rotWithShape="0">
            <a:blip r:embed="rId4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161 Rectángulo"/>
          <p:cNvSpPr/>
          <p:nvPr/>
        </p:nvSpPr>
        <p:spPr>
          <a:xfrm>
            <a:off x="1749600" y="977760"/>
            <a:ext cx="215640" cy="443160"/>
          </a:xfrm>
          <a:prstGeom prst="rect">
            <a:avLst/>
          </a:prstGeom>
          <a:blipFill rotWithShape="0">
            <a:blip r:embed="rId5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162 Rectángulo"/>
          <p:cNvSpPr/>
          <p:nvPr/>
        </p:nvSpPr>
        <p:spPr>
          <a:xfrm>
            <a:off x="1281240" y="977760"/>
            <a:ext cx="195120" cy="443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164 Rectángulo"/>
          <p:cNvSpPr/>
          <p:nvPr/>
        </p:nvSpPr>
        <p:spPr>
          <a:xfrm>
            <a:off x="1476360" y="968400"/>
            <a:ext cx="250920" cy="442800"/>
          </a:xfrm>
          <a:prstGeom prst="rect">
            <a:avLst/>
          </a:prstGeom>
          <a:blipFill rotWithShape="0">
            <a:blip r:embed="rId6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165 Rectángulo"/>
          <p:cNvSpPr/>
          <p:nvPr/>
        </p:nvSpPr>
        <p:spPr>
          <a:xfrm>
            <a:off x="1087560" y="973080"/>
            <a:ext cx="196560" cy="444600"/>
          </a:xfrm>
          <a:prstGeom prst="rect">
            <a:avLst/>
          </a:prstGeom>
          <a:blipFill rotWithShape="0">
            <a:blip r:embed="rId7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166 Rectángulo"/>
          <p:cNvSpPr/>
          <p:nvPr/>
        </p:nvSpPr>
        <p:spPr>
          <a:xfrm>
            <a:off x="542880" y="977760"/>
            <a:ext cx="265320" cy="443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167 Rectángulo"/>
          <p:cNvSpPr/>
          <p:nvPr/>
        </p:nvSpPr>
        <p:spPr>
          <a:xfrm>
            <a:off x="809640" y="968400"/>
            <a:ext cx="252360" cy="442800"/>
          </a:xfrm>
          <a:prstGeom prst="rect">
            <a:avLst/>
          </a:prstGeom>
          <a:blipFill rotWithShape="0">
            <a:blip r:embed="rId8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183 Rectángulo"/>
          <p:cNvSpPr/>
          <p:nvPr/>
        </p:nvSpPr>
        <p:spPr>
          <a:xfrm>
            <a:off x="5630760" y="4649760"/>
            <a:ext cx="104760" cy="442800"/>
          </a:xfrm>
          <a:prstGeom prst="rect">
            <a:avLst/>
          </a:prstGeom>
          <a:blipFill rotWithShape="0">
            <a:blip r:embed="rId9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184 Rectángulo"/>
          <p:cNvSpPr/>
          <p:nvPr/>
        </p:nvSpPr>
        <p:spPr>
          <a:xfrm>
            <a:off x="5332320" y="4649760"/>
            <a:ext cx="312840" cy="442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185 Rectángulo"/>
          <p:cNvSpPr/>
          <p:nvPr/>
        </p:nvSpPr>
        <p:spPr>
          <a:xfrm>
            <a:off x="5079960" y="4649760"/>
            <a:ext cx="252360" cy="442800"/>
          </a:xfrm>
          <a:prstGeom prst="rect">
            <a:avLst/>
          </a:prstGeom>
          <a:blipFill rotWithShape="0">
            <a:blip r:embed="rId10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186 Rectángulo"/>
          <p:cNvSpPr/>
          <p:nvPr/>
        </p:nvSpPr>
        <p:spPr>
          <a:xfrm>
            <a:off x="4976640" y="4649760"/>
            <a:ext cx="105120" cy="442800"/>
          </a:xfrm>
          <a:prstGeom prst="rect">
            <a:avLst/>
          </a:prstGeom>
          <a:blipFill rotWithShape="0">
            <a:blip r:embed="rId11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187 Rectángulo"/>
          <p:cNvSpPr/>
          <p:nvPr/>
        </p:nvSpPr>
        <p:spPr>
          <a:xfrm>
            <a:off x="4676760" y="4649760"/>
            <a:ext cx="314280" cy="442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188 Rectángulo"/>
          <p:cNvSpPr/>
          <p:nvPr/>
        </p:nvSpPr>
        <p:spPr>
          <a:xfrm>
            <a:off x="4425840" y="4649760"/>
            <a:ext cx="250920" cy="442800"/>
          </a:xfrm>
          <a:prstGeom prst="rect">
            <a:avLst/>
          </a:prstGeom>
          <a:blipFill rotWithShape="0">
            <a:blip r:embed="rId12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189 Rectángulo"/>
          <p:cNvSpPr/>
          <p:nvPr/>
        </p:nvSpPr>
        <p:spPr>
          <a:xfrm>
            <a:off x="4251240" y="4648320"/>
            <a:ext cx="104760" cy="442800"/>
          </a:xfrm>
          <a:prstGeom prst="rect">
            <a:avLst/>
          </a:prstGeom>
          <a:blipFill rotWithShape="0">
            <a:blip r:embed="rId13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190 Rectángulo"/>
          <p:cNvSpPr/>
          <p:nvPr/>
        </p:nvSpPr>
        <p:spPr>
          <a:xfrm>
            <a:off x="3959280" y="4648320"/>
            <a:ext cx="312840" cy="442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191 Rectángulo"/>
          <p:cNvSpPr/>
          <p:nvPr/>
        </p:nvSpPr>
        <p:spPr>
          <a:xfrm>
            <a:off x="3710160" y="4640400"/>
            <a:ext cx="252360" cy="442800"/>
          </a:xfrm>
          <a:prstGeom prst="rect">
            <a:avLst/>
          </a:prstGeom>
          <a:blipFill rotWithShape="0">
            <a:blip r:embed="rId14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192 Rectángulo"/>
          <p:cNvSpPr/>
          <p:nvPr/>
        </p:nvSpPr>
        <p:spPr>
          <a:xfrm>
            <a:off x="2827440" y="4654440"/>
            <a:ext cx="104760" cy="443160"/>
          </a:xfrm>
          <a:prstGeom prst="rect">
            <a:avLst/>
          </a:prstGeom>
          <a:blipFill rotWithShape="0">
            <a:blip r:embed="rId15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193 Rectángulo"/>
          <p:cNvSpPr/>
          <p:nvPr/>
        </p:nvSpPr>
        <p:spPr>
          <a:xfrm>
            <a:off x="2529000" y="4654440"/>
            <a:ext cx="312480" cy="443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194 Rectángulo"/>
          <p:cNvSpPr/>
          <p:nvPr/>
        </p:nvSpPr>
        <p:spPr>
          <a:xfrm>
            <a:off x="2276640" y="4654440"/>
            <a:ext cx="252360" cy="443160"/>
          </a:xfrm>
          <a:prstGeom prst="rect">
            <a:avLst/>
          </a:prstGeom>
          <a:blipFill rotWithShape="0">
            <a:blip r:embed="rId16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195 Rectángulo"/>
          <p:cNvSpPr/>
          <p:nvPr/>
        </p:nvSpPr>
        <p:spPr>
          <a:xfrm>
            <a:off x="2101680" y="4648320"/>
            <a:ext cx="61920" cy="442800"/>
          </a:xfrm>
          <a:prstGeom prst="rect">
            <a:avLst/>
          </a:prstGeom>
          <a:blipFill rotWithShape="0">
            <a:blip r:embed="rId17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196 Rectángulo"/>
          <p:cNvSpPr/>
          <p:nvPr/>
        </p:nvSpPr>
        <p:spPr>
          <a:xfrm>
            <a:off x="1803240" y="4648320"/>
            <a:ext cx="312840" cy="442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197 Rectángulo"/>
          <p:cNvSpPr/>
          <p:nvPr/>
        </p:nvSpPr>
        <p:spPr>
          <a:xfrm>
            <a:off x="1550880" y="4648320"/>
            <a:ext cx="252360" cy="442800"/>
          </a:xfrm>
          <a:prstGeom prst="rect">
            <a:avLst/>
          </a:prstGeom>
          <a:blipFill rotWithShape="0">
            <a:blip r:embed="rId18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199 Rectángulo"/>
          <p:cNvSpPr/>
          <p:nvPr/>
        </p:nvSpPr>
        <p:spPr>
          <a:xfrm>
            <a:off x="3409920" y="4648320"/>
            <a:ext cx="276120" cy="442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200 Rectángulo"/>
          <p:cNvSpPr/>
          <p:nvPr/>
        </p:nvSpPr>
        <p:spPr>
          <a:xfrm>
            <a:off x="3159000" y="4648320"/>
            <a:ext cx="250920" cy="442800"/>
          </a:xfrm>
          <a:prstGeom prst="rect">
            <a:avLst/>
          </a:prstGeom>
          <a:blipFill rotWithShape="0">
            <a:blip r:embed="rId19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201 Rectángulo"/>
          <p:cNvSpPr/>
          <p:nvPr/>
        </p:nvSpPr>
        <p:spPr>
          <a:xfrm>
            <a:off x="2932200" y="4654440"/>
            <a:ext cx="209520" cy="443160"/>
          </a:xfrm>
          <a:prstGeom prst="rect">
            <a:avLst/>
          </a:prstGeom>
          <a:blipFill rotWithShape="0">
            <a:blip r:embed="rId20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202 Rectángulo"/>
          <p:cNvSpPr/>
          <p:nvPr/>
        </p:nvSpPr>
        <p:spPr>
          <a:xfrm>
            <a:off x="1407960" y="4659480"/>
            <a:ext cx="136800" cy="442800"/>
          </a:xfrm>
          <a:prstGeom prst="rect">
            <a:avLst/>
          </a:prstGeom>
          <a:blipFill rotWithShape="0">
            <a:blip r:embed="rId21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203 Rectángulo"/>
          <p:cNvSpPr/>
          <p:nvPr/>
        </p:nvSpPr>
        <p:spPr>
          <a:xfrm>
            <a:off x="1360440" y="4648320"/>
            <a:ext cx="46080" cy="442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204 Rectángulo"/>
          <p:cNvSpPr/>
          <p:nvPr/>
        </p:nvSpPr>
        <p:spPr>
          <a:xfrm>
            <a:off x="1108080" y="4648320"/>
            <a:ext cx="252360" cy="442800"/>
          </a:xfrm>
          <a:prstGeom prst="rect">
            <a:avLst/>
          </a:prstGeom>
          <a:blipFill rotWithShape="0">
            <a:blip r:embed="rId22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205 Rectángulo"/>
          <p:cNvSpPr/>
          <p:nvPr/>
        </p:nvSpPr>
        <p:spPr>
          <a:xfrm>
            <a:off x="4365720" y="4651200"/>
            <a:ext cx="60120" cy="443160"/>
          </a:xfrm>
          <a:prstGeom prst="rect">
            <a:avLst/>
          </a:prstGeom>
          <a:blipFill rotWithShape="0">
            <a:blip r:embed="rId23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21 Conector recto"/>
          <p:cNvSpPr/>
          <p:nvPr/>
        </p:nvSpPr>
        <p:spPr>
          <a:xfrm flipV="1">
            <a:off x="1079640" y="398160"/>
            <a:ext cx="502920" cy="43164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24 Conector recto"/>
          <p:cNvSpPr/>
          <p:nvPr/>
        </p:nvSpPr>
        <p:spPr>
          <a:xfrm flipV="1">
            <a:off x="1298520" y="404640"/>
            <a:ext cx="504720" cy="43200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26 Conector recto"/>
          <p:cNvSpPr/>
          <p:nvPr/>
        </p:nvSpPr>
        <p:spPr>
          <a:xfrm flipV="1">
            <a:off x="1763640" y="404640"/>
            <a:ext cx="504720" cy="43200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28 Conector recto"/>
          <p:cNvSpPr/>
          <p:nvPr/>
        </p:nvSpPr>
        <p:spPr>
          <a:xfrm flipV="1">
            <a:off x="1979640" y="404640"/>
            <a:ext cx="504720" cy="43200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30 Conector recto"/>
          <p:cNvSpPr/>
          <p:nvPr/>
        </p:nvSpPr>
        <p:spPr>
          <a:xfrm flipV="1">
            <a:off x="531720" y="393480"/>
            <a:ext cx="505080" cy="43164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36 Conector recto"/>
          <p:cNvSpPr/>
          <p:nvPr/>
        </p:nvSpPr>
        <p:spPr>
          <a:xfrm flipV="1">
            <a:off x="2627280" y="404640"/>
            <a:ext cx="504720" cy="43200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56 Conector recto"/>
          <p:cNvSpPr/>
          <p:nvPr/>
        </p:nvSpPr>
        <p:spPr>
          <a:xfrm flipV="1">
            <a:off x="1090440" y="4051080"/>
            <a:ext cx="505080" cy="43164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58 Conector recto"/>
          <p:cNvSpPr/>
          <p:nvPr/>
        </p:nvSpPr>
        <p:spPr>
          <a:xfrm flipV="1">
            <a:off x="1403280" y="4055760"/>
            <a:ext cx="504720" cy="43164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76 Conector recto"/>
          <p:cNvSpPr/>
          <p:nvPr/>
        </p:nvSpPr>
        <p:spPr>
          <a:xfrm flipV="1">
            <a:off x="1547640" y="4149360"/>
            <a:ext cx="503280" cy="43164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79 Conector recto"/>
          <p:cNvSpPr/>
          <p:nvPr/>
        </p:nvSpPr>
        <p:spPr>
          <a:xfrm flipV="1">
            <a:off x="3687840" y="4055760"/>
            <a:ext cx="503280" cy="43164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82 Conector recto"/>
          <p:cNvSpPr/>
          <p:nvPr/>
        </p:nvSpPr>
        <p:spPr>
          <a:xfrm flipV="1">
            <a:off x="2916360" y="4055760"/>
            <a:ext cx="503280" cy="43164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85 Conector recto"/>
          <p:cNvSpPr/>
          <p:nvPr/>
        </p:nvSpPr>
        <p:spPr>
          <a:xfrm flipV="1">
            <a:off x="2152800" y="4055760"/>
            <a:ext cx="504720" cy="43164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88 Conector recto"/>
          <p:cNvSpPr/>
          <p:nvPr/>
        </p:nvSpPr>
        <p:spPr>
          <a:xfrm flipV="1">
            <a:off x="3141720" y="4055760"/>
            <a:ext cx="503280" cy="43164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91 Conector recto"/>
          <p:cNvSpPr/>
          <p:nvPr/>
        </p:nvSpPr>
        <p:spPr>
          <a:xfrm flipV="1">
            <a:off x="2273400" y="4055760"/>
            <a:ext cx="503280" cy="43164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94 Conector recto"/>
          <p:cNvSpPr/>
          <p:nvPr/>
        </p:nvSpPr>
        <p:spPr>
          <a:xfrm flipV="1">
            <a:off x="4359240" y="4055760"/>
            <a:ext cx="503280" cy="43164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97 Conector recto"/>
          <p:cNvSpPr/>
          <p:nvPr/>
        </p:nvSpPr>
        <p:spPr>
          <a:xfrm flipV="1">
            <a:off x="5079960" y="4055760"/>
            <a:ext cx="503280" cy="43164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100 Conector recto"/>
          <p:cNvSpPr/>
          <p:nvPr/>
        </p:nvSpPr>
        <p:spPr>
          <a:xfrm flipV="1">
            <a:off x="5724360" y="4055760"/>
            <a:ext cx="503280" cy="43164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103 Conector recto"/>
          <p:cNvSpPr/>
          <p:nvPr/>
        </p:nvSpPr>
        <p:spPr>
          <a:xfrm flipV="1">
            <a:off x="4425840" y="4055760"/>
            <a:ext cx="503280" cy="43164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115 Conector recto"/>
          <p:cNvSpPr/>
          <p:nvPr/>
        </p:nvSpPr>
        <p:spPr>
          <a:xfrm flipV="1">
            <a:off x="7112160" y="4508640"/>
            <a:ext cx="0" cy="57600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126 Conector recto"/>
          <p:cNvSpPr/>
          <p:nvPr/>
        </p:nvSpPr>
        <p:spPr>
          <a:xfrm flipV="1">
            <a:off x="7112160" y="4055760"/>
            <a:ext cx="502920" cy="43164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128 Conector recto"/>
          <p:cNvSpPr/>
          <p:nvPr/>
        </p:nvSpPr>
        <p:spPr>
          <a:xfrm flipV="1">
            <a:off x="7164360" y="4509720"/>
            <a:ext cx="0" cy="57636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129 Conector recto"/>
          <p:cNvSpPr/>
          <p:nvPr/>
        </p:nvSpPr>
        <p:spPr>
          <a:xfrm flipV="1">
            <a:off x="7164360" y="4078080"/>
            <a:ext cx="503280" cy="43164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131 Conector recto"/>
          <p:cNvSpPr/>
          <p:nvPr/>
        </p:nvSpPr>
        <p:spPr>
          <a:xfrm flipV="1">
            <a:off x="8591400" y="4508640"/>
            <a:ext cx="0" cy="57600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132 Conector recto"/>
          <p:cNvSpPr/>
          <p:nvPr/>
        </p:nvSpPr>
        <p:spPr>
          <a:xfrm flipV="1">
            <a:off x="8591400" y="4055760"/>
            <a:ext cx="503280" cy="43164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134 Conector recto"/>
          <p:cNvSpPr/>
          <p:nvPr/>
        </p:nvSpPr>
        <p:spPr>
          <a:xfrm flipV="1">
            <a:off x="8639280" y="4509720"/>
            <a:ext cx="0" cy="57636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135 Conector recto"/>
          <p:cNvSpPr/>
          <p:nvPr/>
        </p:nvSpPr>
        <p:spPr>
          <a:xfrm flipV="1">
            <a:off x="8639280" y="4078080"/>
            <a:ext cx="504720" cy="43164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138 Conector recto"/>
          <p:cNvSpPr/>
          <p:nvPr/>
        </p:nvSpPr>
        <p:spPr>
          <a:xfrm flipV="1">
            <a:off x="8891640" y="4066920"/>
            <a:ext cx="504720" cy="43164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2 Rectángulo"/>
          <p:cNvSpPr/>
          <p:nvPr/>
        </p:nvSpPr>
        <p:spPr>
          <a:xfrm>
            <a:off x="1079640" y="4641840"/>
            <a:ext cx="7885080" cy="44280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1 Rectángulo"/>
          <p:cNvSpPr/>
          <p:nvPr/>
        </p:nvSpPr>
        <p:spPr>
          <a:xfrm>
            <a:off x="531720" y="977760"/>
            <a:ext cx="2082960" cy="44316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3 CuadroTexto"/>
          <p:cNvSpPr/>
          <p:nvPr/>
        </p:nvSpPr>
        <p:spPr>
          <a:xfrm>
            <a:off x="5662440" y="1112760"/>
            <a:ext cx="2436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HeT-A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representatio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102 Conector recto"/>
          <p:cNvSpPr/>
          <p:nvPr/>
        </p:nvSpPr>
        <p:spPr>
          <a:xfrm flipV="1">
            <a:off x="4425840" y="4508640"/>
            <a:ext cx="0" cy="57600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99 Conector recto"/>
          <p:cNvSpPr/>
          <p:nvPr/>
        </p:nvSpPr>
        <p:spPr>
          <a:xfrm flipV="1">
            <a:off x="5724360" y="4508640"/>
            <a:ext cx="0" cy="57600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96 Conector recto"/>
          <p:cNvSpPr/>
          <p:nvPr/>
        </p:nvSpPr>
        <p:spPr>
          <a:xfrm flipV="1">
            <a:off x="5079960" y="4508640"/>
            <a:ext cx="0" cy="57600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93 Conector recto"/>
          <p:cNvSpPr/>
          <p:nvPr/>
        </p:nvSpPr>
        <p:spPr>
          <a:xfrm flipV="1">
            <a:off x="4359240" y="4508640"/>
            <a:ext cx="0" cy="57600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81 Conector recto"/>
          <p:cNvSpPr/>
          <p:nvPr/>
        </p:nvSpPr>
        <p:spPr>
          <a:xfrm flipV="1">
            <a:off x="2916360" y="4508640"/>
            <a:ext cx="0" cy="57600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84 Conector recto"/>
          <p:cNvSpPr/>
          <p:nvPr/>
        </p:nvSpPr>
        <p:spPr>
          <a:xfrm flipV="1">
            <a:off x="2152800" y="4508640"/>
            <a:ext cx="0" cy="57600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57 Conector recto"/>
          <p:cNvSpPr/>
          <p:nvPr/>
        </p:nvSpPr>
        <p:spPr>
          <a:xfrm flipV="1">
            <a:off x="1403280" y="4508640"/>
            <a:ext cx="0" cy="57600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18 Conector recto"/>
          <p:cNvSpPr/>
          <p:nvPr/>
        </p:nvSpPr>
        <p:spPr>
          <a:xfrm flipV="1">
            <a:off x="1079640" y="844200"/>
            <a:ext cx="0" cy="57636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23 Conector recto"/>
          <p:cNvSpPr/>
          <p:nvPr/>
        </p:nvSpPr>
        <p:spPr>
          <a:xfrm flipV="1">
            <a:off x="1281240" y="825120"/>
            <a:ext cx="0" cy="57636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25 Conector recto"/>
          <p:cNvSpPr/>
          <p:nvPr/>
        </p:nvSpPr>
        <p:spPr>
          <a:xfrm flipV="1">
            <a:off x="1746360" y="844200"/>
            <a:ext cx="0" cy="57636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27 Conector recto"/>
          <p:cNvSpPr/>
          <p:nvPr/>
        </p:nvSpPr>
        <p:spPr>
          <a:xfrm flipV="1">
            <a:off x="1965240" y="855360"/>
            <a:ext cx="0" cy="57636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29 Conector recto"/>
          <p:cNvSpPr/>
          <p:nvPr/>
        </p:nvSpPr>
        <p:spPr>
          <a:xfrm flipV="1">
            <a:off x="533520" y="825120"/>
            <a:ext cx="0" cy="57636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35 Conector recto"/>
          <p:cNvSpPr/>
          <p:nvPr/>
        </p:nvSpPr>
        <p:spPr>
          <a:xfrm flipV="1">
            <a:off x="2617920" y="836280"/>
            <a:ext cx="0" cy="57636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55 Conector recto"/>
          <p:cNvSpPr/>
          <p:nvPr/>
        </p:nvSpPr>
        <p:spPr>
          <a:xfrm flipV="1">
            <a:off x="1090440" y="4487400"/>
            <a:ext cx="0" cy="57636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75 Conector recto"/>
          <p:cNvSpPr/>
          <p:nvPr/>
        </p:nvSpPr>
        <p:spPr>
          <a:xfrm flipV="1">
            <a:off x="1544760" y="4581360"/>
            <a:ext cx="0" cy="50328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78 Conector recto"/>
          <p:cNvSpPr/>
          <p:nvPr/>
        </p:nvSpPr>
        <p:spPr>
          <a:xfrm flipV="1">
            <a:off x="3687840" y="4508640"/>
            <a:ext cx="0" cy="57600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87 Conector recto"/>
          <p:cNvSpPr/>
          <p:nvPr/>
        </p:nvSpPr>
        <p:spPr>
          <a:xfrm flipV="1">
            <a:off x="3141720" y="4508640"/>
            <a:ext cx="0" cy="57600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90 Conector recto"/>
          <p:cNvSpPr/>
          <p:nvPr/>
        </p:nvSpPr>
        <p:spPr>
          <a:xfrm flipV="1">
            <a:off x="2273400" y="4508640"/>
            <a:ext cx="0" cy="57600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18T08:31:28Z</dcterms:created>
  <dc:creator>David</dc:creator>
  <dc:description/>
  <dc:language>en-US</dc:language>
  <cp:lastModifiedBy>Elena Casacuberta</cp:lastModifiedBy>
  <dcterms:modified xsi:type="dcterms:W3CDTF">2011-11-18T08:36:49Z</dcterms:modified>
  <cp:revision>313</cp:revision>
  <dc:subject/>
  <dc:title>Presentación de PowerPoint</dc:title>
</cp:coreProperties>
</file>